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5BF4D-6680-4108-86D1-180C3F4734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6C0D9-1D14-4482-9422-8DC7B4A612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78C5C-4BBB-4505-B395-926E8EA1F0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1CAAF-6725-4748-9AB6-6EE1D5381D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6DB1CE-5A39-4F1A-9B9F-D2928BBABA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32C52-BBA3-4350-B0EE-55E44B149E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456BE-62CE-4B5C-B5BC-4CF92256CC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1F8A23-36CD-4C40-8929-A7BC13A500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E1718-9779-47CE-975C-CEDD6EBCFD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265F4-9D63-4BB2-A054-1DA78E59C9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2ED09-7A3A-4424-9750-6D5575E992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40AD6-1CF1-48F2-A6CD-18288DD3AF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6938DB-B55A-4BBB-A00F-781C57689089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43080" y="573120"/>
            <a:ext cx="8366040" cy="6069600"/>
            <a:chOff x="343080" y="573120"/>
            <a:chExt cx="8366040" cy="6069600"/>
          </a:xfrm>
        </p:grpSpPr>
        <p:grpSp>
          <p:nvGrpSpPr>
            <p:cNvPr id="42" name=""/>
            <p:cNvGrpSpPr/>
            <p:nvPr/>
          </p:nvGrpSpPr>
          <p:grpSpPr>
            <a:xfrm>
              <a:off x="343080" y="870120"/>
              <a:ext cx="1706400" cy="4611960"/>
              <a:chOff x="343080" y="870120"/>
              <a:chExt cx="1706400" cy="4611960"/>
            </a:xfrm>
          </p:grpSpPr>
          <p:grpSp>
            <p:nvGrpSpPr>
              <p:cNvPr id="43" name=""/>
              <p:cNvGrpSpPr/>
              <p:nvPr/>
            </p:nvGrpSpPr>
            <p:grpSpPr>
              <a:xfrm>
                <a:off x="736560" y="2379600"/>
                <a:ext cx="879480" cy="231120"/>
                <a:chOff x="736560" y="2379600"/>
                <a:chExt cx="879480" cy="231120"/>
              </a:xfrm>
            </p:grpSpPr>
            <p:sp>
              <p:nvSpPr>
                <p:cNvPr id="44" name=""/>
                <p:cNvSpPr/>
                <p:nvPr/>
              </p:nvSpPr>
              <p:spPr>
                <a:xfrm>
                  <a:off x="736560" y="2500200"/>
                  <a:ext cx="144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5" name=""/>
                <p:cNvSpPr/>
                <p:nvPr/>
              </p:nvSpPr>
              <p:spPr>
                <a:xfrm>
                  <a:off x="824040" y="2379600"/>
                  <a:ext cx="792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8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46" name=""/>
              <p:cNvGrpSpPr/>
              <p:nvPr/>
            </p:nvGrpSpPr>
            <p:grpSpPr>
              <a:xfrm>
                <a:off x="736560" y="4175280"/>
                <a:ext cx="879480" cy="231120"/>
                <a:chOff x="736560" y="4175280"/>
                <a:chExt cx="879480" cy="231120"/>
              </a:xfrm>
            </p:grpSpPr>
            <p:sp>
              <p:nvSpPr>
                <p:cNvPr id="47" name=""/>
                <p:cNvSpPr/>
                <p:nvPr/>
              </p:nvSpPr>
              <p:spPr>
                <a:xfrm>
                  <a:off x="736560" y="4281480"/>
                  <a:ext cx="144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824040" y="4175280"/>
                  <a:ext cx="792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18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49" name=""/>
              <p:cNvGrpSpPr/>
              <p:nvPr/>
            </p:nvGrpSpPr>
            <p:grpSpPr>
              <a:xfrm>
                <a:off x="736560" y="4381560"/>
                <a:ext cx="1312920" cy="642600"/>
                <a:chOff x="736560" y="4381560"/>
                <a:chExt cx="1312920" cy="642600"/>
              </a:xfrm>
            </p:grpSpPr>
            <p:sp>
              <p:nvSpPr>
                <p:cNvPr id="50" name=""/>
                <p:cNvSpPr/>
                <p:nvPr/>
              </p:nvSpPr>
              <p:spPr>
                <a:xfrm>
                  <a:off x="736560" y="4505400"/>
                  <a:ext cx="144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>
                  <a:off x="824040" y="4381560"/>
                  <a:ext cx="1225440" cy="642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19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19b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19c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19d (Pbprp2)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881280" y="4405320"/>
                  <a:ext cx="71280" cy="574560"/>
                </a:xfrm>
                <a:custGeom>
                  <a:avLst/>
                  <a:gdLst>
                    <a:gd name="textAreaLeft" fmla="*/ 20880 w 71280"/>
                    <a:gd name="textAreaRight" fmla="*/ 71640 w 71280"/>
                    <a:gd name="textAreaTop" fmla="*/ 0 h 574560"/>
                    <a:gd name="textAreaBottom" fmla="*/ 574920 h 57456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0800" y="0"/>
                        <a:pt x="0" y="0"/>
                        <a:pt x="0" y="0"/>
                      </a:cubicBezTo>
                      <a:lnTo>
                        <a:pt x="0" y="21600"/>
                      </a:lnTo>
                      <a:cubicBezTo>
                        <a:pt x="0" y="21600"/>
                        <a:pt x="108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53" name=""/>
              <p:cNvGrpSpPr/>
              <p:nvPr/>
            </p:nvGrpSpPr>
            <p:grpSpPr>
              <a:xfrm>
                <a:off x="343080" y="870120"/>
                <a:ext cx="792000" cy="4611960"/>
                <a:chOff x="343080" y="870120"/>
                <a:chExt cx="792000" cy="4611960"/>
              </a:xfrm>
            </p:grpSpPr>
            <p:sp>
              <p:nvSpPr>
                <p:cNvPr id="54" name=""/>
                <p:cNvSpPr/>
                <p:nvPr/>
              </p:nvSpPr>
              <p:spPr>
                <a:xfrm flipV="1">
                  <a:off x="736560" y="870120"/>
                  <a:ext cx="0" cy="3993840"/>
                </a:xfrm>
                <a:prstGeom prst="line">
                  <a:avLst/>
                </a:prstGeom>
                <a:ln w="442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662040" y="4856040"/>
                  <a:ext cx="144360" cy="14472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343080" y="5083200"/>
                  <a:ext cx="79200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spcBef>
                      <a:spcPts val="1250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2000" spc="-1" strike="noStrike">
                      <a:solidFill>
                        <a:srgbClr val="000000"/>
                      </a:solidFill>
                      <a:latin typeface="Arial"/>
                    </a:rPr>
                    <a:t>X(A)</a:t>
                  </a:r>
                  <a:endParaRPr b="0" lang="en-US" sz="20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grpSp>
          <p:nvGrpSpPr>
            <p:cNvPr id="57" name=""/>
            <p:cNvGrpSpPr/>
            <p:nvPr/>
          </p:nvGrpSpPr>
          <p:grpSpPr>
            <a:xfrm>
              <a:off x="5180040" y="870120"/>
              <a:ext cx="1693800" cy="4980240"/>
              <a:chOff x="5180040" y="870120"/>
              <a:chExt cx="1693800" cy="4980240"/>
            </a:xfrm>
          </p:grpSpPr>
          <p:grpSp>
            <p:nvGrpSpPr>
              <p:cNvPr id="58" name=""/>
              <p:cNvGrpSpPr/>
              <p:nvPr/>
            </p:nvGrpSpPr>
            <p:grpSpPr>
              <a:xfrm>
                <a:off x="5632560" y="2981520"/>
                <a:ext cx="1241280" cy="231120"/>
                <a:chOff x="5632560" y="2981520"/>
                <a:chExt cx="1241280" cy="231120"/>
              </a:xfrm>
            </p:grpSpPr>
            <p:sp>
              <p:nvSpPr>
                <p:cNvPr id="59" name=""/>
                <p:cNvSpPr/>
                <p:nvPr/>
              </p:nvSpPr>
              <p:spPr>
                <a:xfrm>
                  <a:off x="5632560" y="30970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5719680" y="2981520"/>
                  <a:ext cx="11541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69a (Pbprp1)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61" name=""/>
              <p:cNvGrpSpPr/>
              <p:nvPr/>
            </p:nvGrpSpPr>
            <p:grpSpPr>
              <a:xfrm>
                <a:off x="5632560" y="4278240"/>
                <a:ext cx="1123920" cy="231120"/>
                <a:chOff x="5632560" y="4278240"/>
                <a:chExt cx="1123920" cy="231120"/>
              </a:xfrm>
            </p:grpSpPr>
            <p:sp>
              <p:nvSpPr>
                <p:cNvPr id="62" name=""/>
                <p:cNvSpPr/>
                <p:nvPr/>
              </p:nvSpPr>
              <p:spPr>
                <a:xfrm>
                  <a:off x="5632560" y="43927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>
                  <a:off x="5718240" y="4278240"/>
                  <a:ext cx="10382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76a (Lush)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64" name=""/>
              <p:cNvGrpSpPr/>
              <p:nvPr/>
            </p:nvGrpSpPr>
            <p:grpSpPr>
              <a:xfrm>
                <a:off x="5180040" y="870120"/>
                <a:ext cx="914400" cy="4980240"/>
                <a:chOff x="5180040" y="870120"/>
                <a:chExt cx="914400" cy="4980240"/>
              </a:xfrm>
            </p:grpSpPr>
            <p:sp>
              <p:nvSpPr>
                <p:cNvPr id="65" name=""/>
                <p:cNvSpPr/>
                <p:nvPr/>
              </p:nvSpPr>
              <p:spPr>
                <a:xfrm flipV="1">
                  <a:off x="5632560" y="870120"/>
                  <a:ext cx="0" cy="4278240"/>
                </a:xfrm>
                <a:prstGeom prst="line">
                  <a:avLst/>
                </a:prstGeom>
                <a:ln w="442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5559480" y="5145120"/>
                  <a:ext cx="144360" cy="14436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5180040" y="5451480"/>
                  <a:ext cx="91440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spcBef>
                      <a:spcPts val="1250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2000" spc="-1" strike="noStrike">
                      <a:solidFill>
                        <a:srgbClr val="000000"/>
                      </a:solidFill>
                      <a:latin typeface="Arial"/>
                    </a:rPr>
                    <a:t>3L(D)</a:t>
                  </a:r>
                  <a:endParaRPr b="0" lang="en-US" sz="20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grpSp>
          <p:nvGrpSpPr>
            <p:cNvPr id="68" name=""/>
            <p:cNvGrpSpPr/>
            <p:nvPr/>
          </p:nvGrpSpPr>
          <p:grpSpPr>
            <a:xfrm>
              <a:off x="1770120" y="870120"/>
              <a:ext cx="1790640" cy="4764240"/>
              <a:chOff x="1770120" y="870120"/>
              <a:chExt cx="1790640" cy="4764240"/>
            </a:xfrm>
          </p:grpSpPr>
          <p:grpSp>
            <p:nvGrpSpPr>
              <p:cNvPr id="69" name=""/>
              <p:cNvGrpSpPr/>
              <p:nvPr/>
            </p:nvGrpSpPr>
            <p:grpSpPr>
              <a:xfrm>
                <a:off x="2247840" y="2104920"/>
                <a:ext cx="1312920" cy="231120"/>
                <a:chOff x="2247840" y="2104920"/>
                <a:chExt cx="1312920" cy="231120"/>
              </a:xfrm>
            </p:grpSpPr>
            <p:sp>
              <p:nvSpPr>
                <p:cNvPr id="70" name=""/>
                <p:cNvSpPr/>
                <p:nvPr/>
              </p:nvSpPr>
              <p:spPr>
                <a:xfrm>
                  <a:off x="2247840" y="2219400"/>
                  <a:ext cx="144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1" name=""/>
                <p:cNvSpPr/>
                <p:nvPr/>
              </p:nvSpPr>
              <p:spPr>
                <a:xfrm>
                  <a:off x="2335320" y="2104920"/>
                  <a:ext cx="12254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28a (Pbprp5)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72" name=""/>
              <p:cNvGrpSpPr/>
              <p:nvPr/>
            </p:nvGrpSpPr>
            <p:grpSpPr>
              <a:xfrm>
                <a:off x="2247840" y="1131840"/>
                <a:ext cx="879480" cy="231120"/>
                <a:chOff x="2247840" y="1131840"/>
                <a:chExt cx="879480" cy="231120"/>
              </a:xfrm>
            </p:grpSpPr>
            <p:sp>
              <p:nvSpPr>
                <p:cNvPr id="73" name=""/>
                <p:cNvSpPr/>
                <p:nvPr/>
              </p:nvSpPr>
              <p:spPr>
                <a:xfrm>
                  <a:off x="2247840" y="1230480"/>
                  <a:ext cx="144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2335320" y="1131840"/>
                  <a:ext cx="792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22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75" name=""/>
              <p:cNvGrpSpPr/>
              <p:nvPr/>
            </p:nvGrpSpPr>
            <p:grpSpPr>
              <a:xfrm>
                <a:off x="1770120" y="870120"/>
                <a:ext cx="914400" cy="4764240"/>
                <a:chOff x="1770120" y="870120"/>
                <a:chExt cx="914400" cy="4764240"/>
              </a:xfrm>
            </p:grpSpPr>
            <p:sp>
              <p:nvSpPr>
                <p:cNvPr id="76" name=""/>
                <p:cNvSpPr/>
                <p:nvPr/>
              </p:nvSpPr>
              <p:spPr>
                <a:xfrm flipV="1">
                  <a:off x="2247840" y="870120"/>
                  <a:ext cx="0" cy="4030560"/>
                </a:xfrm>
                <a:prstGeom prst="line">
                  <a:avLst/>
                </a:prstGeom>
                <a:ln w="442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2171880" y="4875120"/>
                  <a:ext cx="144360" cy="14472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>
                  <a:off x="1770120" y="5235480"/>
                  <a:ext cx="91440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spcBef>
                      <a:spcPts val="1250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2000" spc="-1" strike="noStrike">
                      <a:solidFill>
                        <a:srgbClr val="000000"/>
                      </a:solidFill>
                      <a:latin typeface="Arial"/>
                    </a:rPr>
                    <a:t>2L(B)</a:t>
                  </a:r>
                  <a:endParaRPr b="0" lang="en-US" sz="20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grpSp>
          <p:nvGrpSpPr>
            <p:cNvPr id="79" name=""/>
            <p:cNvGrpSpPr/>
            <p:nvPr/>
          </p:nvGrpSpPr>
          <p:grpSpPr>
            <a:xfrm>
              <a:off x="3343320" y="725400"/>
              <a:ext cx="1585800" cy="4548600"/>
              <a:chOff x="3343320" y="725400"/>
              <a:chExt cx="1585800" cy="4548600"/>
            </a:xfrm>
          </p:grpSpPr>
          <p:grpSp>
            <p:nvGrpSpPr>
              <p:cNvPr id="80" name=""/>
              <p:cNvGrpSpPr/>
              <p:nvPr/>
            </p:nvGrpSpPr>
            <p:grpSpPr>
              <a:xfrm>
                <a:off x="4048200" y="1795320"/>
                <a:ext cx="789120" cy="231120"/>
                <a:chOff x="4048200" y="1795320"/>
                <a:chExt cx="789120" cy="231120"/>
              </a:xfrm>
            </p:grpSpPr>
            <p:sp>
              <p:nvSpPr>
                <p:cNvPr id="81" name=""/>
                <p:cNvSpPr/>
                <p:nvPr/>
              </p:nvSpPr>
              <p:spPr>
                <a:xfrm>
                  <a:off x="4048200" y="191916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4135680" y="1795320"/>
                  <a:ext cx="7016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46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83" name=""/>
              <p:cNvGrpSpPr/>
              <p:nvPr/>
            </p:nvGrpSpPr>
            <p:grpSpPr>
              <a:xfrm>
                <a:off x="4048200" y="2224080"/>
                <a:ext cx="879480" cy="231120"/>
                <a:chOff x="4048200" y="2224080"/>
                <a:chExt cx="879480" cy="231120"/>
              </a:xfrm>
            </p:grpSpPr>
            <p:sp>
              <p:nvSpPr>
                <p:cNvPr id="84" name=""/>
                <p:cNvSpPr/>
                <p:nvPr/>
              </p:nvSpPr>
              <p:spPr>
                <a:xfrm>
                  <a:off x="4048200" y="23446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>
                  <a:off x="4135680" y="2224080"/>
                  <a:ext cx="792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49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86" name=""/>
              <p:cNvGrpSpPr/>
              <p:nvPr/>
            </p:nvGrpSpPr>
            <p:grpSpPr>
              <a:xfrm>
                <a:off x="4048200" y="2668680"/>
                <a:ext cx="879480" cy="231120"/>
                <a:chOff x="4048200" y="2668680"/>
                <a:chExt cx="879480" cy="231120"/>
              </a:xfrm>
            </p:grpSpPr>
            <p:sp>
              <p:nvSpPr>
                <p:cNvPr id="87" name=""/>
                <p:cNvSpPr/>
                <p:nvPr/>
              </p:nvSpPr>
              <p:spPr>
                <a:xfrm>
                  <a:off x="4048200" y="276696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>
                  <a:off x="4135680" y="2668680"/>
                  <a:ext cx="792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1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89" name=""/>
              <p:cNvGrpSpPr/>
              <p:nvPr/>
            </p:nvGrpSpPr>
            <p:grpSpPr>
              <a:xfrm>
                <a:off x="4048200" y="1995480"/>
                <a:ext cx="879480" cy="231120"/>
                <a:chOff x="4048200" y="1995480"/>
                <a:chExt cx="879480" cy="231120"/>
              </a:xfrm>
            </p:grpSpPr>
            <p:sp>
              <p:nvSpPr>
                <p:cNvPr id="90" name=""/>
                <p:cNvSpPr/>
                <p:nvPr/>
              </p:nvSpPr>
              <p:spPr>
                <a:xfrm>
                  <a:off x="4048200" y="209700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4135680" y="1995480"/>
                  <a:ext cx="792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47b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92" name=""/>
              <p:cNvGrpSpPr/>
              <p:nvPr/>
            </p:nvGrpSpPr>
            <p:grpSpPr>
              <a:xfrm>
                <a:off x="4048200" y="1409760"/>
                <a:ext cx="879480" cy="231120"/>
                <a:chOff x="4048200" y="1409760"/>
                <a:chExt cx="879480" cy="231120"/>
              </a:xfrm>
            </p:grpSpPr>
            <p:sp>
              <p:nvSpPr>
                <p:cNvPr id="93" name=""/>
                <p:cNvSpPr/>
                <p:nvPr/>
              </p:nvSpPr>
              <p:spPr>
                <a:xfrm>
                  <a:off x="4048200" y="15238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4135680" y="1409760"/>
                  <a:ext cx="792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44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95" name=""/>
              <p:cNvGrpSpPr/>
              <p:nvPr/>
            </p:nvGrpSpPr>
            <p:grpSpPr>
              <a:xfrm>
                <a:off x="3345120" y="2262240"/>
                <a:ext cx="792000" cy="779760"/>
                <a:chOff x="3345120" y="2262240"/>
                <a:chExt cx="792000" cy="779760"/>
              </a:xfrm>
            </p:grpSpPr>
            <p:sp>
              <p:nvSpPr>
                <p:cNvPr id="96" name=""/>
                <p:cNvSpPr/>
                <p:nvPr/>
              </p:nvSpPr>
              <p:spPr>
                <a:xfrm>
                  <a:off x="3903840" y="264780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3345120" y="2262240"/>
                  <a:ext cx="792000" cy="779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0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0b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0c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0d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0e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3832200" y="2290680"/>
                  <a:ext cx="71640" cy="719280"/>
                </a:xfrm>
                <a:custGeom>
                  <a:avLst/>
                  <a:gdLst>
                    <a:gd name="textAreaLeft" fmla="*/ 0 w 71640"/>
                    <a:gd name="textAreaRight" fmla="*/ 50400 w 71640"/>
                    <a:gd name="textAreaTop" fmla="*/ 0 h 719280"/>
                    <a:gd name="textAreaBottom" fmla="*/ 719640 h 71928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10800" y="0"/>
                        <a:pt x="21600" y="0"/>
                        <a:pt x="21600" y="0"/>
                      </a:cubicBezTo>
                      <a:lnTo>
                        <a:pt x="21600" y="21600"/>
                      </a:lnTo>
                      <a:cubicBezTo>
                        <a:pt x="21600" y="21600"/>
                        <a:pt x="108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99" name=""/>
              <p:cNvGrpSpPr/>
              <p:nvPr/>
            </p:nvGrpSpPr>
            <p:grpSpPr>
              <a:xfrm>
                <a:off x="3343320" y="3871800"/>
                <a:ext cx="936720" cy="642600"/>
                <a:chOff x="3343320" y="3871800"/>
                <a:chExt cx="936720" cy="642600"/>
              </a:xfrm>
            </p:grpSpPr>
            <p:sp>
              <p:nvSpPr>
                <p:cNvPr id="100" name=""/>
                <p:cNvSpPr/>
                <p:nvPr/>
              </p:nvSpPr>
              <p:spPr>
                <a:xfrm flipH="1">
                  <a:off x="3908160" y="41482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3343320" y="3871800"/>
                  <a:ext cx="936720" cy="642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9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8b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8c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8d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 rot="10800000">
                  <a:off x="3831840" y="3911760"/>
                  <a:ext cx="71640" cy="574560"/>
                </a:xfrm>
                <a:custGeom>
                  <a:avLst/>
                  <a:gdLst>
                    <a:gd name="textAreaLeft" fmla="*/ 20880 w 71640"/>
                    <a:gd name="textAreaRight" fmla="*/ 72000 w 71640"/>
                    <a:gd name="textAreaTop" fmla="*/ 0 h 574560"/>
                    <a:gd name="textAreaBottom" fmla="*/ 574920 h 57456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0800" y="0"/>
                        <a:pt x="0" y="0"/>
                        <a:pt x="0" y="0"/>
                      </a:cubicBezTo>
                      <a:lnTo>
                        <a:pt x="0" y="21600"/>
                      </a:lnTo>
                      <a:cubicBezTo>
                        <a:pt x="0" y="21600"/>
                        <a:pt x="108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03" name=""/>
              <p:cNvGrpSpPr/>
              <p:nvPr/>
            </p:nvGrpSpPr>
            <p:grpSpPr>
              <a:xfrm>
                <a:off x="4055760" y="2948040"/>
                <a:ext cx="871920" cy="1328400"/>
                <a:chOff x="4055760" y="2948040"/>
                <a:chExt cx="871920" cy="1328400"/>
              </a:xfrm>
            </p:grpSpPr>
            <p:sp>
              <p:nvSpPr>
                <p:cNvPr id="104" name=""/>
                <p:cNvSpPr/>
                <p:nvPr/>
              </p:nvSpPr>
              <p:spPr>
                <a:xfrm flipH="1">
                  <a:off x="4055760" y="36226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4135680" y="2948040"/>
                  <a:ext cx="792000" cy="1328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6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6b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6c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6d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6e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6f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6g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6h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6i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 rot="10800000">
                  <a:off x="4200120" y="2992320"/>
                  <a:ext cx="71640" cy="1224000"/>
                </a:xfrm>
                <a:custGeom>
                  <a:avLst/>
                  <a:gdLst>
                    <a:gd name="textAreaLeft" fmla="*/ 0 w 71640"/>
                    <a:gd name="textAreaRight" fmla="*/ 50400 w 71640"/>
                    <a:gd name="textAreaTop" fmla="*/ 0 h 1224000"/>
                    <a:gd name="textAreaBottom" fmla="*/ 1224360 h 122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10800" y="0"/>
                        <a:pt x="21600" y="0"/>
                        <a:pt x="21600" y="0"/>
                      </a:cubicBezTo>
                      <a:lnTo>
                        <a:pt x="21600" y="21600"/>
                      </a:lnTo>
                      <a:cubicBezTo>
                        <a:pt x="21600" y="21600"/>
                        <a:pt x="108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07" name=""/>
              <p:cNvGrpSpPr/>
              <p:nvPr/>
            </p:nvGrpSpPr>
            <p:grpSpPr>
              <a:xfrm>
                <a:off x="3343320" y="3113280"/>
                <a:ext cx="792360" cy="779760"/>
                <a:chOff x="3343320" y="3113280"/>
                <a:chExt cx="792360" cy="779760"/>
              </a:xfrm>
            </p:grpSpPr>
            <p:sp>
              <p:nvSpPr>
                <p:cNvPr id="108" name=""/>
                <p:cNvSpPr/>
                <p:nvPr/>
              </p:nvSpPr>
              <p:spPr>
                <a:xfrm flipH="1">
                  <a:off x="3917880" y="3755880"/>
                  <a:ext cx="144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3343320" y="3113280"/>
                  <a:ext cx="792360" cy="779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7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7b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7c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7d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57e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 rot="10800000">
                  <a:off x="3831840" y="3144600"/>
                  <a:ext cx="71640" cy="718920"/>
                </a:xfrm>
                <a:custGeom>
                  <a:avLst/>
                  <a:gdLst>
                    <a:gd name="textAreaLeft" fmla="*/ 20880 w 71640"/>
                    <a:gd name="textAreaRight" fmla="*/ 72000 w 71640"/>
                    <a:gd name="textAreaTop" fmla="*/ 0 h 718920"/>
                    <a:gd name="textAreaBottom" fmla="*/ 719280 h 7189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0800" y="0"/>
                        <a:pt x="0" y="0"/>
                        <a:pt x="0" y="0"/>
                      </a:cubicBezTo>
                      <a:lnTo>
                        <a:pt x="0" y="21600"/>
                      </a:lnTo>
                      <a:cubicBezTo>
                        <a:pt x="0" y="21600"/>
                        <a:pt x="108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11" name=""/>
              <p:cNvGrpSpPr/>
              <p:nvPr/>
            </p:nvGrpSpPr>
            <p:grpSpPr>
              <a:xfrm>
                <a:off x="3556080" y="725400"/>
                <a:ext cx="987480" cy="4548600"/>
                <a:chOff x="3556080" y="725400"/>
                <a:chExt cx="987480" cy="4548600"/>
              </a:xfrm>
            </p:grpSpPr>
            <p:sp>
              <p:nvSpPr>
                <p:cNvPr id="112" name=""/>
                <p:cNvSpPr/>
                <p:nvPr/>
              </p:nvSpPr>
              <p:spPr>
                <a:xfrm flipV="1">
                  <a:off x="4048200" y="870120"/>
                  <a:ext cx="0" cy="3735360"/>
                </a:xfrm>
                <a:prstGeom prst="line">
                  <a:avLst/>
                </a:prstGeom>
                <a:ln w="442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3975120" y="725400"/>
                  <a:ext cx="144360" cy="14472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3556080" y="4875120"/>
                  <a:ext cx="98748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spcBef>
                      <a:spcPts val="1250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2000" spc="-1" strike="noStrike">
                      <a:solidFill>
                        <a:srgbClr val="000000"/>
                      </a:solidFill>
                      <a:latin typeface="Arial"/>
                    </a:rPr>
                    <a:t>2R(C)</a:t>
                  </a:r>
                  <a:endParaRPr b="0" lang="en-US" sz="20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15" name=""/>
              <p:cNvGrpSpPr/>
              <p:nvPr/>
            </p:nvGrpSpPr>
            <p:grpSpPr>
              <a:xfrm>
                <a:off x="4049640" y="1892160"/>
                <a:ext cx="879480" cy="231120"/>
                <a:chOff x="4049640" y="1892160"/>
                <a:chExt cx="879480" cy="231120"/>
              </a:xfrm>
            </p:grpSpPr>
            <p:sp>
              <p:nvSpPr>
                <p:cNvPr id="116" name=""/>
                <p:cNvSpPr/>
                <p:nvPr/>
              </p:nvSpPr>
              <p:spPr>
                <a:xfrm>
                  <a:off x="4049640" y="2025720"/>
                  <a:ext cx="144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4137120" y="1892160"/>
                  <a:ext cx="792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47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grpSp>
          <p:nvGrpSpPr>
            <p:cNvPr id="118" name=""/>
            <p:cNvGrpSpPr/>
            <p:nvPr/>
          </p:nvGrpSpPr>
          <p:grpSpPr>
            <a:xfrm>
              <a:off x="6966000" y="573120"/>
              <a:ext cx="1743120" cy="6069600"/>
              <a:chOff x="6966000" y="573120"/>
              <a:chExt cx="1743120" cy="6069600"/>
            </a:xfrm>
          </p:grpSpPr>
          <p:grpSp>
            <p:nvGrpSpPr>
              <p:cNvPr id="119" name=""/>
              <p:cNvGrpSpPr/>
              <p:nvPr/>
            </p:nvGrpSpPr>
            <p:grpSpPr>
              <a:xfrm>
                <a:off x="7432920" y="1314360"/>
                <a:ext cx="1276200" cy="231120"/>
                <a:chOff x="7432920" y="1314360"/>
                <a:chExt cx="1276200" cy="231120"/>
              </a:xfrm>
            </p:grpSpPr>
            <p:sp>
              <p:nvSpPr>
                <p:cNvPr id="120" name=""/>
                <p:cNvSpPr/>
                <p:nvPr/>
              </p:nvSpPr>
              <p:spPr>
                <a:xfrm>
                  <a:off x="7432920" y="142416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7520040" y="1314360"/>
                  <a:ext cx="11890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84a (Pbprp4)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22" name=""/>
              <p:cNvGrpSpPr/>
              <p:nvPr/>
            </p:nvGrpSpPr>
            <p:grpSpPr>
              <a:xfrm>
                <a:off x="7432920" y="3808440"/>
                <a:ext cx="879480" cy="231120"/>
                <a:chOff x="7432920" y="3808440"/>
                <a:chExt cx="879480" cy="231120"/>
              </a:xfrm>
            </p:grpSpPr>
            <p:sp>
              <p:nvSpPr>
                <p:cNvPr id="123" name=""/>
                <p:cNvSpPr/>
                <p:nvPr/>
              </p:nvSpPr>
              <p:spPr>
                <a:xfrm>
                  <a:off x="7432920" y="39211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7520040" y="3808440"/>
                  <a:ext cx="7923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93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25" name=""/>
              <p:cNvGrpSpPr/>
              <p:nvPr/>
            </p:nvGrpSpPr>
            <p:grpSpPr>
              <a:xfrm>
                <a:off x="7432920" y="1525680"/>
                <a:ext cx="879480" cy="231120"/>
                <a:chOff x="7432920" y="1525680"/>
                <a:chExt cx="879480" cy="231120"/>
              </a:xfrm>
            </p:grpSpPr>
            <p:sp>
              <p:nvSpPr>
                <p:cNvPr id="126" name=""/>
                <p:cNvSpPr/>
                <p:nvPr/>
              </p:nvSpPr>
              <p:spPr>
                <a:xfrm>
                  <a:off x="7432920" y="16336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7520040" y="1525680"/>
                  <a:ext cx="7923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85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28" name=""/>
              <p:cNvGrpSpPr/>
              <p:nvPr/>
            </p:nvGrpSpPr>
            <p:grpSpPr>
              <a:xfrm>
                <a:off x="7432920" y="5135760"/>
                <a:ext cx="1023840" cy="642600"/>
                <a:chOff x="7432920" y="5135760"/>
                <a:chExt cx="1023840" cy="642600"/>
              </a:xfrm>
            </p:grpSpPr>
            <p:sp>
              <p:nvSpPr>
                <p:cNvPr id="129" name=""/>
                <p:cNvSpPr/>
                <p:nvPr/>
              </p:nvSpPr>
              <p:spPr>
                <a:xfrm>
                  <a:off x="7432920" y="546264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0" name=""/>
                <p:cNvSpPr/>
                <p:nvPr/>
              </p:nvSpPr>
              <p:spPr>
                <a:xfrm>
                  <a:off x="7520040" y="5135760"/>
                  <a:ext cx="936720" cy="642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99a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99c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99d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99b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>
                  <a:off x="7577280" y="5159520"/>
                  <a:ext cx="71280" cy="574560"/>
                </a:xfrm>
                <a:custGeom>
                  <a:avLst/>
                  <a:gdLst>
                    <a:gd name="textAreaLeft" fmla="*/ 20880 w 71280"/>
                    <a:gd name="textAreaRight" fmla="*/ 71640 w 71280"/>
                    <a:gd name="textAreaTop" fmla="*/ 0 h 574560"/>
                    <a:gd name="textAreaBottom" fmla="*/ 574920 h 57456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0800" y="0"/>
                        <a:pt x="0" y="0"/>
                        <a:pt x="0" y="0"/>
                      </a:cubicBezTo>
                      <a:lnTo>
                        <a:pt x="0" y="21600"/>
                      </a:lnTo>
                      <a:cubicBezTo>
                        <a:pt x="0" y="21600"/>
                        <a:pt x="108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32" name=""/>
              <p:cNvGrpSpPr/>
              <p:nvPr/>
            </p:nvGrpSpPr>
            <p:grpSpPr>
              <a:xfrm>
                <a:off x="7432920" y="573120"/>
                <a:ext cx="1276200" cy="779760"/>
                <a:chOff x="7432920" y="573120"/>
                <a:chExt cx="1276200" cy="779760"/>
              </a:xfrm>
            </p:grpSpPr>
            <p:sp>
              <p:nvSpPr>
                <p:cNvPr id="133" name=""/>
                <p:cNvSpPr/>
                <p:nvPr/>
              </p:nvSpPr>
              <p:spPr>
                <a:xfrm>
                  <a:off x="7432920" y="121140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7520040" y="573120"/>
                  <a:ext cx="1189080" cy="779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83a (Pbprp3)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83b (Os-E)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83cd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83ef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900" spc="-1" strike="noStrike">
                      <a:solidFill>
                        <a:srgbClr val="000000"/>
                      </a:solidFill>
                      <a:latin typeface="Arial"/>
                    </a:rPr>
                    <a:t>Obp83g</a:t>
                  </a:r>
                  <a:endParaRPr b="0" lang="en-US" sz="9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5" name=""/>
                <p:cNvSpPr/>
                <p:nvPr/>
              </p:nvSpPr>
              <p:spPr>
                <a:xfrm>
                  <a:off x="7575480" y="627120"/>
                  <a:ext cx="71640" cy="685800"/>
                </a:xfrm>
                <a:custGeom>
                  <a:avLst/>
                  <a:gdLst>
                    <a:gd name="textAreaLeft" fmla="*/ 20880 w 71640"/>
                    <a:gd name="textAreaRight" fmla="*/ 72000 w 71640"/>
                    <a:gd name="textAreaTop" fmla="*/ 0 h 685800"/>
                    <a:gd name="textAreaBottom" fmla="*/ 686160 h 6858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0800" y="0"/>
                        <a:pt x="0" y="0"/>
                        <a:pt x="0" y="0"/>
                      </a:cubicBezTo>
                      <a:lnTo>
                        <a:pt x="0" y="21600"/>
                      </a:lnTo>
                      <a:cubicBezTo>
                        <a:pt x="0" y="21600"/>
                        <a:pt x="108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36" name=""/>
              <p:cNvGrpSpPr/>
              <p:nvPr/>
            </p:nvGrpSpPr>
            <p:grpSpPr>
              <a:xfrm>
                <a:off x="6966000" y="723960"/>
                <a:ext cx="914400" cy="5918760"/>
                <a:chOff x="6966000" y="723960"/>
                <a:chExt cx="914400" cy="5918760"/>
              </a:xfrm>
            </p:grpSpPr>
            <p:sp>
              <p:nvSpPr>
                <p:cNvPr id="137" name=""/>
                <p:cNvSpPr/>
                <p:nvPr/>
              </p:nvSpPr>
              <p:spPr>
                <a:xfrm flipV="1">
                  <a:off x="7432920" y="869760"/>
                  <a:ext cx="0" cy="5019480"/>
                </a:xfrm>
                <a:prstGeom prst="line">
                  <a:avLst/>
                </a:prstGeom>
                <a:ln w="442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>
                  <a:off x="7359840" y="723960"/>
                  <a:ext cx="144360" cy="14436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9" name=""/>
                <p:cNvSpPr/>
                <p:nvPr/>
              </p:nvSpPr>
              <p:spPr>
                <a:xfrm>
                  <a:off x="6966000" y="6243840"/>
                  <a:ext cx="91440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spcBef>
                      <a:spcPts val="1250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ES_tradnl" sz="2000" spc="-1" strike="noStrike">
                      <a:solidFill>
                        <a:srgbClr val="000000"/>
                      </a:solidFill>
                      <a:latin typeface="Arial"/>
                    </a:rPr>
                    <a:t>3R(E)</a:t>
                  </a:r>
                  <a:endParaRPr b="0" lang="en-US" sz="20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</p:grpSp>
      <p:sp>
        <p:nvSpPr>
          <p:cNvPr id="140" name=""/>
          <p:cNvSpPr/>
          <p:nvPr/>
        </p:nvSpPr>
        <p:spPr>
          <a:xfrm>
            <a:off x="826920" y="4362480"/>
            <a:ext cx="1081080" cy="666720"/>
          </a:xfrm>
          <a:prstGeom prst="rect">
            <a:avLst/>
          </a:prstGeom>
          <a:solidFill>
            <a:srgbClr val="808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1454040" y="438156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666633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42" name=""/>
          <p:cNvGrpSpPr/>
          <p:nvPr/>
        </p:nvGrpSpPr>
        <p:grpSpPr>
          <a:xfrm>
            <a:off x="3017880" y="2252520"/>
            <a:ext cx="936720" cy="794520"/>
            <a:chOff x="3017880" y="2252520"/>
            <a:chExt cx="936720" cy="794520"/>
          </a:xfrm>
        </p:grpSpPr>
        <p:sp>
          <p:nvSpPr>
            <p:cNvPr id="143" name=""/>
            <p:cNvSpPr/>
            <p:nvPr/>
          </p:nvSpPr>
          <p:spPr>
            <a:xfrm>
              <a:off x="3378240" y="2252520"/>
              <a:ext cx="576360" cy="792000"/>
            </a:xfrm>
            <a:prstGeom prst="rect">
              <a:avLst/>
            </a:prstGeom>
            <a:solidFill>
              <a:srgbClr val="969696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017880" y="2739960"/>
              <a:ext cx="360360" cy="307080"/>
            </a:xfrm>
            <a:prstGeom prst="rect">
              <a:avLst/>
            </a:prstGeom>
            <a:solidFill>
              <a:srgbClr val="969696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4d4d4d"/>
                  </a:solidFill>
                  <a:latin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45" name=""/>
          <p:cNvSpPr/>
          <p:nvPr/>
        </p:nvSpPr>
        <p:spPr>
          <a:xfrm>
            <a:off x="3379680" y="3141720"/>
            <a:ext cx="576360" cy="430200"/>
          </a:xfrm>
          <a:prstGeom prst="rect">
            <a:avLst/>
          </a:prstGeom>
          <a:solidFill>
            <a:srgbClr val="80008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3019320" y="3265560"/>
            <a:ext cx="360360" cy="307080"/>
          </a:xfrm>
          <a:prstGeom prst="rect">
            <a:avLst/>
          </a:prstGeom>
          <a:solidFill>
            <a:srgbClr val="80008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990099"/>
                </a:solidFill>
                <a:latin typeface="Arial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3376440" y="3886200"/>
            <a:ext cx="576360" cy="630360"/>
          </a:xfrm>
          <a:prstGeom prst="rect">
            <a:avLst/>
          </a:prstGeom>
          <a:solidFill>
            <a:srgbClr val="ff66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3016080" y="4211640"/>
            <a:ext cx="360360" cy="307080"/>
          </a:xfrm>
          <a:prstGeom prst="rect">
            <a:avLst/>
          </a:prstGeom>
          <a:solidFill>
            <a:srgbClr val="ff66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6600"/>
                </a:solidFill>
                <a:latin typeface="Arial"/>
              </a:rPr>
              <a:t>7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4132440" y="2941560"/>
            <a:ext cx="576000" cy="881280"/>
          </a:xfrm>
          <a:prstGeom prst="rect">
            <a:avLst/>
          </a:prstGeom>
          <a:solidFill>
            <a:srgbClr val="ffff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4708440" y="3524400"/>
            <a:ext cx="360360" cy="307080"/>
          </a:xfrm>
          <a:prstGeom prst="rect">
            <a:avLst/>
          </a:prstGeom>
          <a:solidFill>
            <a:srgbClr val="ffff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66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7529400" y="573120"/>
            <a:ext cx="1370160" cy="333360"/>
          </a:xfrm>
          <a:prstGeom prst="rect">
            <a:avLst/>
          </a:prstGeom>
          <a:solidFill>
            <a:srgbClr val="3366ff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7539120" y="5307120"/>
            <a:ext cx="633240" cy="45864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8172360" y="5459400"/>
            <a:ext cx="417600" cy="30708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cc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7531200" y="906480"/>
            <a:ext cx="641160" cy="434880"/>
          </a:xfrm>
          <a:prstGeom prst="rect">
            <a:avLst/>
          </a:prstGeom>
          <a:solidFill>
            <a:srgbClr val="00ff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3025800" y="3573360"/>
            <a:ext cx="925560" cy="287280"/>
          </a:xfrm>
          <a:prstGeom prst="rect">
            <a:avLst/>
          </a:prstGeom>
          <a:solidFill>
            <a:srgbClr val="00808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3025800" y="355428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66cc"/>
                </a:solidFill>
                <a:latin typeface="Arial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8172360" y="1038240"/>
            <a:ext cx="360360" cy="307080"/>
          </a:xfrm>
          <a:prstGeom prst="rect">
            <a:avLst/>
          </a:prstGeom>
          <a:solidFill>
            <a:srgbClr val="00ff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9900"/>
                </a:solidFill>
                <a:latin typeface="Arial"/>
              </a:rPr>
              <a:t>9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8539200" y="57312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3333cc"/>
                </a:solidFill>
                <a:latin typeface="Arial"/>
              </a:rPr>
              <a:t>8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4132440" y="3832200"/>
            <a:ext cx="576000" cy="432000"/>
          </a:xfrm>
          <a:prstGeom prst="rect">
            <a:avLst/>
          </a:prstGeom>
          <a:solidFill>
            <a:srgbClr val="9933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4708440" y="3960720"/>
            <a:ext cx="360360" cy="307080"/>
          </a:xfrm>
          <a:prstGeom prst="rect">
            <a:avLst/>
          </a:prstGeom>
          <a:solidFill>
            <a:srgbClr val="9933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990033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5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Julio Rozas</cp:lastModifiedBy>
  <dcterms:modified xsi:type="dcterms:W3CDTF">2007-09-15T15:36:01Z</dcterms:modified>
  <cp:revision>688</cp:revision>
  <dc:subject/>
  <dc:title>PowerPoint Presentation</dc:title>
</cp:coreProperties>
</file>